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90" d="100"/>
          <a:sy n="90" d="100"/>
        </p:scale>
        <p:origin x="72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F84C66-6F6A-4F60-9D8D-D9AD4FDC0B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A84C9A1-839C-487F-93C9-3C76C87AB9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78D4D2-58A6-4D1D-AE7F-A9A67B112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EC3E6D-C938-4733-AE87-5DE8C5858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B4D3F0-5D27-42BC-8082-174944A05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507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8F2BC9-F97E-4197-B8CD-337A467869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39D0ADD-0ACB-4E7B-9E60-B5F545DD37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680D97-BFCE-464E-A8EC-2492EF1E9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2EBAC4-529E-4F81-BA46-CDE4DAA14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51CEA1-047F-4796-B37E-54E4C5D71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612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D317040-C5C4-424F-925F-AF7740719E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8C753AA-4ACC-49E0-B0BE-52B0AA7AF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F49463-2212-4688-B8A8-4C811BE1F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971223-7F12-4DF7-B5C2-854EC6454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ABEBA54-46A0-469B-B54F-FDC7AE919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0204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CB8D22-DA14-4098-92F3-C46EA1ED10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28B97-F25F-4EAA-A837-8C86563C45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01D3-7E16-4272-9C9E-8C019C8F5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5104C5A-4ED8-45B5-9A9E-84053EA25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FB0F055-A6D4-4ABF-A2CA-7E13752E3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8072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81831D-AB71-4578-B497-362DB987A0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155E2AD-4D19-4DF8-A8C5-709E7C051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08D3740-A86C-4333-8DC9-AE2737D00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D4AF32-FD0B-43E7-BF96-366C38BD3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041E153-207A-43D3-BF5F-7C65B2CB1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4340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431E58-A709-4DA2-8398-CD0FA8F3FB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68F399C-FA54-4C1A-AA3B-D5A56B9803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0DC35BB-F190-4FD9-A2DC-22BA4A12A7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83AA9C5-AAA3-4BC2-AED5-54488D5AB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AA2B001-DFA2-4B8B-80AB-F2E69C88A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84E0BC-0543-428D-A632-BA5F03558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6404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77764B-27FD-4811-BBFD-86CF3D3E54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9CC2C43-D630-42D3-A233-D1ED93B98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1AD0797-BEB2-40C9-A3A3-9E687F4F6B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911945F-9870-490C-8571-5C9F2402D1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12D63B0-4D57-40FA-A03F-D0D0F941B5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EA577EC-329B-46D3-AFF0-4F830D78B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B8471D6-93AA-4B87-B890-724D098CC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E86C6BE-9297-43D0-A2B2-7FB85982C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9741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E2C298-5F61-4D43-9EF2-1573ADB462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2B2C274-2CE7-41D4-818B-E79119BB0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A3C5360-1FD3-431F-823D-62CA8BF87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5E498B8-3963-48BE-A774-009880DBC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0506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4FDB2FC-8B9E-4C6C-930C-12A635A74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195C3D0-C6ED-463C-9C0A-1D9F6C51D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8629F91-BA59-47D0-876F-57DC497E1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3386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4F1982-9A06-4E29-8EF9-F42387498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519E718-0A67-47C6-B319-2CA3201921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DD0D8B6-F8B3-4CE8-98E7-30E2A95AD9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76F8F50-7419-41E8-A84E-34B410EF0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B21043-6493-447E-A4FC-DB8A54E98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DA8FCF-8BF5-4729-B162-07CE3F8B5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1530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23AAF3-D694-4A6A-BF26-E4E6822AD2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A91151E-162A-4D70-B21D-E4E64DC446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FD44D1-F5DB-4211-BC52-A26BC9F152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87CD975-3BF3-4BF4-A7BC-EB016A4EB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B2AC4DE-CA93-404A-9BA8-237332A79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5F13079-3DEC-44A5-8AF7-254FD3410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791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E0DC70A-C251-4BAD-9554-A3A1A6EDFB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594E027-1548-4BA3-8565-D99720FB29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4611BA4-AD72-4461-89C5-148597941F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8C001-E8A9-4C5F-B6D2-83BBB86FD134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431D66-9CD2-4309-925D-715B5E3F77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6ADA7D-C391-4E8C-9BFF-F683099ACF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0B8B9-56CA-4406-A01A-851BD00417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3095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78063" y="247680"/>
            <a:ext cx="11747012" cy="6037484"/>
            <a:chOff x="-27037" y="247680"/>
            <a:chExt cx="11747012" cy="6037484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7D068381-654B-455A-8AD6-DD61C7C23104}"/>
                </a:ext>
              </a:extLst>
            </p:cNvPr>
            <p:cNvSpPr txBox="1"/>
            <p:nvPr/>
          </p:nvSpPr>
          <p:spPr>
            <a:xfrm>
              <a:off x="5507273" y="5094732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pi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218647" y="288229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pi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254879" y="2079450"/>
              <a:ext cx="20123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fr-FR" sz="1400" b="1" dirty="0" err="1"/>
                <a:t>wild</a:t>
              </a:r>
              <a:r>
                <a:rPr lang="fr-FR" sz="1400" b="1" dirty="0"/>
                <a:t>-type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218647" y="3688941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-27037" y="4502294"/>
              <a:ext cx="28088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el-GR" sz="1400" b="1" dirty="0"/>
                <a:t>Δ</a:t>
              </a:r>
              <a:r>
                <a:rPr lang="fr-FR" sz="1400" b="1" i="1" dirty="0" err="1"/>
                <a:t>invA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2C50DD77-AD82-4A09-9D1B-BA65F43B8CE2}"/>
                </a:ext>
              </a:extLst>
            </p:cNvPr>
            <p:cNvSpPr txBox="1"/>
            <p:nvPr/>
          </p:nvSpPr>
          <p:spPr>
            <a:xfrm>
              <a:off x="5470741" y="2826662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pi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1385067D-7DB2-4E0E-89AA-BA4E85F051C4}"/>
                </a:ext>
              </a:extLst>
            </p:cNvPr>
            <p:cNvSpPr txBox="1"/>
            <p:nvPr/>
          </p:nvSpPr>
          <p:spPr>
            <a:xfrm>
              <a:off x="9236479" y="509473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pi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236479" y="600816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507273" y="573170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pi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pic>
        <p:nvPicPr>
          <p:cNvPr id="25" name="Picture 4">
            <a:extLst>
              <a:ext uri="{FF2B5EF4-FFF2-40B4-BE49-F238E27FC236}">
                <a16:creationId xmlns:a16="http://schemas.microsoft.com/office/drawing/2014/main" id="{8EE8D977-C673-4947-81BD-0834BA3683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1373" y="227904"/>
            <a:ext cx="1893142" cy="1982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7" descr="C:\Users\trs-confocal\AppData\Local\Temp\tmp13241897065992597230.png">
            <a:extLst>
              <a:ext uri="{FF2B5EF4-FFF2-40B4-BE49-F238E27FC236}">
                <a16:creationId xmlns:a16="http://schemas.microsoft.com/office/drawing/2014/main" id="{302DE4DB-B758-4A0E-81D8-366D5321E4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43557" y="247680"/>
            <a:ext cx="1872720" cy="19609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1" descr="C:\Users\trs-confocal\AppData\Local\Temp\tmp08881333175835658468.png">
            <a:extLst>
              <a:ext uri="{FF2B5EF4-FFF2-40B4-BE49-F238E27FC236}">
                <a16:creationId xmlns:a16="http://schemas.microsoft.com/office/drawing/2014/main" id="{46FA4960-8E04-4DDC-B833-E4523D6D4EF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2422" y="2463462"/>
            <a:ext cx="1862093" cy="1949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4" descr="C:\Users\trs-confocal\AppData\Local\Temp\tmp16272323819163272731.png">
            <a:extLst>
              <a:ext uri="{FF2B5EF4-FFF2-40B4-BE49-F238E27FC236}">
                <a16:creationId xmlns:a16="http://schemas.microsoft.com/office/drawing/2014/main" id="{589CED0C-C7A9-4867-BEA8-52EF472898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5137" y="2457399"/>
            <a:ext cx="1861140" cy="19488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4" descr="C:\Users\trs-confocal\AppData\Local\Temp\tmp06623695140782867117.png">
            <a:extLst>
              <a:ext uri="{FF2B5EF4-FFF2-40B4-BE49-F238E27FC236}">
                <a16:creationId xmlns:a16="http://schemas.microsoft.com/office/drawing/2014/main" id="{0DC3CA27-A63B-4B2A-850B-E843E70B0D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231" y="4680297"/>
            <a:ext cx="1862093" cy="194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7" descr="C:\Users\trs-confocal\AppData\Local\Temp\tmp11199080096581728131.png">
            <a:extLst>
              <a:ext uri="{FF2B5EF4-FFF2-40B4-BE49-F238E27FC236}">
                <a16:creationId xmlns:a16="http://schemas.microsoft.com/office/drawing/2014/main" id="{190E6548-3890-4AEE-9CB3-256DE38427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5137" y="4637424"/>
            <a:ext cx="1849910" cy="19370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" name="ZoneTexte 40">
            <a:extLst>
              <a:ext uri="{FF2B5EF4-FFF2-40B4-BE49-F238E27FC236}">
                <a16:creationId xmlns:a16="http://schemas.microsoft.com/office/drawing/2014/main" id="{767BB29B-24FB-4CE7-8123-E1A816F4AC24}"/>
              </a:ext>
            </a:extLst>
          </p:cNvPr>
          <p:cNvSpPr txBox="1"/>
          <p:nvPr/>
        </p:nvSpPr>
        <p:spPr>
          <a:xfrm>
            <a:off x="10205545" y="291263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5 </a:t>
            </a:r>
            <a:r>
              <a:rPr lang="fr-FR" b="1"/>
              <a:t>Fig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14704921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2</cp:revision>
  <dcterms:created xsi:type="dcterms:W3CDTF">2020-06-04T06:32:28Z</dcterms:created>
  <dcterms:modified xsi:type="dcterms:W3CDTF">2020-09-18T09:07:44Z</dcterms:modified>
</cp:coreProperties>
</file>